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8" r:id="rId2"/>
    <p:sldId id="260" r:id="rId3"/>
    <p:sldId id="256" r:id="rId4"/>
    <p:sldId id="257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94660"/>
  </p:normalViewPr>
  <p:slideViewPr>
    <p:cSldViewPr snapToGrid="0">
      <p:cViewPr varScale="1">
        <p:scale>
          <a:sx n="71" d="100"/>
          <a:sy n="71" d="100"/>
        </p:scale>
        <p:origin x="20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02AEDB-6C7F-457C-ABCC-A43E83E088D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1FAAD4-1832-47AB-81FA-E12C23A6A1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241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3: Ingenuity Pathway Analysis (IPA) modified summary reduced to 1 pag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PA modified summary for transcriptomics of astrocytes treated with GBM F3-8 EV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1FAAD4-1832-47AB-81FA-E12C23A6A12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8026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4: IPA modified summary reduced to 1 pag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PA modified summary for transcriptomics of astrocytes treated with GBM G17-1 EV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1FAAD4-1832-47AB-81FA-E12C23A6A12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7287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5: IPA modified summary reduced to 1 pag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PA modified summary for proteomics of astrocytes treated with GBM F3-8 EV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1FAAD4-1832-47AB-81FA-E12C23A6A12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5450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6: IPA modified summary reduced to 1 page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PA modified summary for proteomics of astrocytes treated with GBM G17-1 EV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1FAAD4-1832-47AB-81FA-E12C23A6A12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255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6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84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35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48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24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277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265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9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01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689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100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82AD2-D01C-4837-BB84-58B929DFFE82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6179A-69DE-4380-9435-F79F0992B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84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13.emf"/><Relationship Id="rId5" Type="http://schemas.openxmlformats.org/officeDocument/2006/relationships/image" Target="../media/image3.emf"/><Relationship Id="rId10" Type="http://schemas.openxmlformats.org/officeDocument/2006/relationships/image" Target="../media/image12.emf"/><Relationship Id="rId4" Type="http://schemas.openxmlformats.org/officeDocument/2006/relationships/image" Target="../media/image2.emf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.emf"/><Relationship Id="rId7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5.emf"/><Relationship Id="rId5" Type="http://schemas.openxmlformats.org/officeDocument/2006/relationships/image" Target="../media/image3.emf"/><Relationship Id="rId10" Type="http://schemas.openxmlformats.org/officeDocument/2006/relationships/image" Target="../media/image19.emf"/><Relationship Id="rId4" Type="http://schemas.openxmlformats.org/officeDocument/2006/relationships/image" Target="../media/image2.emf"/><Relationship Id="rId9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EB7E910F-29F1-41F5-2E7A-F4A5A3C7948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797" t="29526" r="4258" b="65766"/>
          <a:stretch/>
        </p:blipFill>
        <p:spPr>
          <a:xfrm>
            <a:off x="253794" y="563043"/>
            <a:ext cx="6305550" cy="22755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36B5933-6CB3-067D-91CA-908D1C1DB4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1051" b="44241"/>
          <a:stretch/>
        </p:blipFill>
        <p:spPr>
          <a:xfrm>
            <a:off x="6350" y="1681854"/>
            <a:ext cx="6858000" cy="22755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7C21C98-193A-FE65-3F5A-923AEE02DA1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5987" r="3981" b="90334"/>
          <a:stretch/>
        </p:blipFill>
        <p:spPr>
          <a:xfrm>
            <a:off x="215900" y="2964350"/>
            <a:ext cx="6305550" cy="1778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FC877AD-7ADA-602B-5F09-31E517A0DE2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37495" r="3981" b="59332"/>
          <a:stretch/>
        </p:blipFill>
        <p:spPr>
          <a:xfrm>
            <a:off x="228600" y="4019451"/>
            <a:ext cx="6305550" cy="15335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BD9D282-1FDA-28CF-9381-DC930602BC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33781" r="3492" b="61173"/>
          <a:stretch/>
        </p:blipFill>
        <p:spPr>
          <a:xfrm>
            <a:off x="219891" y="5086909"/>
            <a:ext cx="6389914" cy="24384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AFF95B7-B66E-2CC5-B55F-D8096D5B23D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73068" r="3492" b="21886"/>
          <a:stretch/>
        </p:blipFill>
        <p:spPr>
          <a:xfrm>
            <a:off x="211181" y="6263052"/>
            <a:ext cx="6389914" cy="24384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6A8354B6-54E7-4916-F273-63021CFBF780}"/>
              </a:ext>
            </a:extLst>
          </p:cNvPr>
          <p:cNvSpPr txBox="1"/>
          <p:nvPr/>
        </p:nvSpPr>
        <p:spPr>
          <a:xfrm>
            <a:off x="6350" y="-26250"/>
            <a:ext cx="15712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S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464ECA-92D7-0C5D-9AAD-1987C1FCB1AC}"/>
              </a:ext>
            </a:extLst>
          </p:cNvPr>
          <p:cNvSpPr txBox="1"/>
          <p:nvPr/>
        </p:nvSpPr>
        <p:spPr>
          <a:xfrm>
            <a:off x="534237" y="286044"/>
            <a:ext cx="7099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PA Modified Transcriptomic Summary, Astrocytes Treated with F3-8 EVs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CFEA778A-67D7-4A0C-4C37-1832B9212C2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83284" r="3492" b="10803"/>
          <a:stretch/>
        </p:blipFill>
        <p:spPr>
          <a:xfrm>
            <a:off x="206825" y="6485159"/>
            <a:ext cx="6389914" cy="285745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ED8061B-8FF6-0725-33FB-74AC9A238A9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364" t="83210" r="22872" b="11033"/>
          <a:stretch/>
        </p:blipFill>
        <p:spPr>
          <a:xfrm>
            <a:off x="2867606" y="6481003"/>
            <a:ext cx="943897" cy="27822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12D3F47-6DD8-4EAA-4C9E-53548B13AF1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56" t="33790" r="94194" b="63020"/>
          <a:stretch/>
        </p:blipFill>
        <p:spPr>
          <a:xfrm>
            <a:off x="243348" y="6749100"/>
            <a:ext cx="147485" cy="154172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20F7732-ADEB-0976-6CDF-193032D3B4D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805" t="83224" r="39969" b="10803"/>
          <a:stretch/>
        </p:blipFill>
        <p:spPr>
          <a:xfrm>
            <a:off x="4041058" y="6482136"/>
            <a:ext cx="1592826" cy="28862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63DBD09-17F2-803A-629C-283F7ABE9D7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70" t="24978" r="4409" b="58697"/>
          <a:stretch/>
        </p:blipFill>
        <p:spPr>
          <a:xfrm>
            <a:off x="228601" y="774290"/>
            <a:ext cx="6290188" cy="78904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0DCDBB8-D0C9-1F66-16E6-C6B4D9060AE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1320" b="35287"/>
          <a:stretch/>
        </p:blipFill>
        <p:spPr>
          <a:xfrm>
            <a:off x="0" y="1906173"/>
            <a:ext cx="6858000" cy="16396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307DA711-9ACF-1706-326F-C38E73FF5F5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870" t="12315" r="5162" b="71208"/>
          <a:stretch/>
        </p:blipFill>
        <p:spPr>
          <a:xfrm>
            <a:off x="221226" y="2050024"/>
            <a:ext cx="6238569" cy="79641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ABD9E65B-AB8E-7A07-6120-6BA3ECFF97B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870" t="43286" r="5162" b="39322"/>
          <a:stretch/>
        </p:blipFill>
        <p:spPr>
          <a:xfrm>
            <a:off x="228600" y="3097163"/>
            <a:ext cx="6238569" cy="840658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94EB3884-8AFC-4CBC-1944-67E5F226C23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870" t="75171" r="5162" b="7895"/>
          <a:stretch/>
        </p:blipFill>
        <p:spPr>
          <a:xfrm>
            <a:off x="235974" y="4166421"/>
            <a:ext cx="6238569" cy="81853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FEFCCB2-028B-3A6F-4A6A-A0E602E0EF5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548" t="68919" r="4624" b="14451"/>
          <a:stretch/>
        </p:blipFill>
        <p:spPr>
          <a:xfrm>
            <a:off x="235974" y="5287297"/>
            <a:ext cx="6297562" cy="80378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A3F2F8D-F8FE-B918-5C6F-B51527C5197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584" t="43163" r="94194" b="53498"/>
          <a:stretch/>
        </p:blipFill>
        <p:spPr>
          <a:xfrm>
            <a:off x="1154877" y="7240904"/>
            <a:ext cx="152400" cy="16138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34E2E66-3F7B-97A9-939D-957F8196B62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942" t="53404" r="94194" b="43927"/>
          <a:stretch/>
        </p:blipFill>
        <p:spPr>
          <a:xfrm>
            <a:off x="2262508" y="7645183"/>
            <a:ext cx="127821" cy="129008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A230A5E1-CF67-EEA1-E387-D78FC707630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3106" t="56073" r="96057" b="42981"/>
          <a:stretch/>
        </p:blipFill>
        <p:spPr>
          <a:xfrm>
            <a:off x="1483037" y="8105856"/>
            <a:ext cx="483414" cy="45719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2603134-FCC2-2957-3DD9-E5563154F59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942" t="65569" r="94194" b="31934"/>
          <a:stretch/>
        </p:blipFill>
        <p:spPr>
          <a:xfrm>
            <a:off x="3126962" y="8207206"/>
            <a:ext cx="127821" cy="12068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3C3E0A15-07F2-26B4-4972-236E360EB90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761" t="76536" r="93657" b="19834"/>
          <a:stretch/>
        </p:blipFill>
        <p:spPr>
          <a:xfrm>
            <a:off x="4223262" y="8490072"/>
            <a:ext cx="176981" cy="17543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A6DC1FAA-6419-3894-2000-CFA61DC21A3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413" t="22894" r="11793" b="72682"/>
          <a:stretch/>
        </p:blipFill>
        <p:spPr>
          <a:xfrm>
            <a:off x="5861289" y="6794596"/>
            <a:ext cx="191729" cy="213853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A324692F-CF33-25E1-D358-1E51E209AF1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413" t="22894" r="11793" b="72682"/>
          <a:stretch/>
        </p:blipFill>
        <p:spPr>
          <a:xfrm>
            <a:off x="5861289" y="7221273"/>
            <a:ext cx="191729" cy="21385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D20E6D6-1C16-F1C6-1053-A37C0570C2E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473" t="20554" r="21290" b="70902"/>
          <a:stretch/>
        </p:blipFill>
        <p:spPr>
          <a:xfrm>
            <a:off x="423712" y="6748111"/>
            <a:ext cx="1113504" cy="412954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C093674F-E3A0-DA92-1521-D17B73D686A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473" t="29098" r="21290" b="62053"/>
          <a:stretch/>
        </p:blipFill>
        <p:spPr>
          <a:xfrm>
            <a:off x="1307277" y="7143831"/>
            <a:ext cx="1113504" cy="427703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93871C9A-031C-002C-B886-C502DBC6AA7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473" t="37795" r="22688" b="50915"/>
          <a:stretch/>
        </p:blipFill>
        <p:spPr>
          <a:xfrm>
            <a:off x="2403032" y="7515817"/>
            <a:ext cx="1017639" cy="54569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1359B1B4-4F4E-AB40-D311-4DA832AAA1E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413" t="41660" r="12222" b="54526"/>
          <a:stretch/>
        </p:blipFill>
        <p:spPr>
          <a:xfrm>
            <a:off x="5876037" y="7578757"/>
            <a:ext cx="162232" cy="184355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B0C43D97-AA4E-948E-1975-50DE80400F8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556" t="51628" r="12222" b="44558"/>
          <a:stretch/>
        </p:blipFill>
        <p:spPr>
          <a:xfrm>
            <a:off x="5880953" y="8036537"/>
            <a:ext cx="152400" cy="184355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D7A9948F-1311-8D0E-B0C2-41E827C4A82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484" t="63731" r="12222" b="32455"/>
          <a:stretch/>
        </p:blipFill>
        <p:spPr>
          <a:xfrm>
            <a:off x="5878495" y="8519315"/>
            <a:ext cx="157317" cy="184355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EEA68CD-5CEA-088A-9BA7-E0CF32B7D12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473" t="48323" r="22688" b="40692"/>
          <a:stretch/>
        </p:blipFill>
        <p:spPr>
          <a:xfrm>
            <a:off x="3254783" y="8005105"/>
            <a:ext cx="1017639" cy="53094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384F3586-5485-C246-6E56-9989CBDF5CE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473" t="59155" r="24194" b="27113"/>
          <a:stretch/>
        </p:blipFill>
        <p:spPr>
          <a:xfrm>
            <a:off x="4400243" y="8315384"/>
            <a:ext cx="914400" cy="664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0361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EB7E910F-29F1-41F5-2E7A-F4A5A3C7948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797" t="29526" r="4258" b="65766"/>
          <a:stretch/>
        </p:blipFill>
        <p:spPr>
          <a:xfrm>
            <a:off x="253794" y="563043"/>
            <a:ext cx="6305550" cy="22755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36B5933-6CB3-067D-91CA-908D1C1DB4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1051" b="44241"/>
          <a:stretch/>
        </p:blipFill>
        <p:spPr>
          <a:xfrm>
            <a:off x="6350" y="1939948"/>
            <a:ext cx="6858000" cy="22755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7C21C98-193A-FE65-3F5A-923AEE02DA1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5987" r="3981" b="90334"/>
          <a:stretch/>
        </p:blipFill>
        <p:spPr>
          <a:xfrm>
            <a:off x="215900" y="3178198"/>
            <a:ext cx="6305550" cy="1778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FC877AD-7ADA-602B-5F09-31E517A0DE2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37495" r="3981" b="59332"/>
          <a:stretch/>
        </p:blipFill>
        <p:spPr>
          <a:xfrm>
            <a:off x="228600" y="4218554"/>
            <a:ext cx="6305550" cy="15335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BD9D282-1FDA-28CF-9381-DC930602BC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33781" r="3492" b="61173"/>
          <a:stretch/>
        </p:blipFill>
        <p:spPr>
          <a:xfrm>
            <a:off x="219891" y="5234394"/>
            <a:ext cx="6389914" cy="24384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AFF95B7-B66E-2CC5-B55F-D8096D5B23D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73068" r="3492" b="21886"/>
          <a:stretch/>
        </p:blipFill>
        <p:spPr>
          <a:xfrm>
            <a:off x="211181" y="6764495"/>
            <a:ext cx="6389914" cy="24384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6A8354B6-54E7-4916-F273-63021CFBF780}"/>
              </a:ext>
            </a:extLst>
          </p:cNvPr>
          <p:cNvSpPr txBox="1"/>
          <p:nvPr/>
        </p:nvSpPr>
        <p:spPr>
          <a:xfrm>
            <a:off x="6350" y="-26250"/>
            <a:ext cx="15712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S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464ECA-92D7-0C5D-9AAD-1987C1FCB1AC}"/>
              </a:ext>
            </a:extLst>
          </p:cNvPr>
          <p:cNvSpPr txBox="1"/>
          <p:nvPr/>
        </p:nvSpPr>
        <p:spPr>
          <a:xfrm>
            <a:off x="534237" y="286044"/>
            <a:ext cx="7099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PA Modified Transcriptomic Summary, Astrocytes Treated with G17-1 EVs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CFEA778A-67D7-4A0C-4C37-1832B9212C2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83284" r="3492" b="10803"/>
          <a:stretch/>
        </p:blipFill>
        <p:spPr>
          <a:xfrm>
            <a:off x="206825" y="6942352"/>
            <a:ext cx="6389914" cy="285745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ED8061B-8FF6-0725-33FB-74AC9A238A9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364" t="83210" r="22872" b="11033"/>
          <a:stretch/>
        </p:blipFill>
        <p:spPr>
          <a:xfrm>
            <a:off x="2867606" y="6938196"/>
            <a:ext cx="943897" cy="27822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20F7732-ADEB-0976-6CDF-193032D3B4D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805" t="83224" r="39969" b="10803"/>
          <a:stretch/>
        </p:blipFill>
        <p:spPr>
          <a:xfrm>
            <a:off x="4041058" y="6939329"/>
            <a:ext cx="1592826" cy="288623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E324861-6AE2-7F4C-C122-B76AA093106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1320" b="35287"/>
          <a:stretch/>
        </p:blipFill>
        <p:spPr>
          <a:xfrm>
            <a:off x="0" y="2149518"/>
            <a:ext cx="6858000" cy="16396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3CF998D-3900-C138-B893-4E741D6CBFD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56" t="33790" r="94194" b="63020"/>
          <a:stretch/>
        </p:blipFill>
        <p:spPr>
          <a:xfrm>
            <a:off x="253061" y="7273153"/>
            <a:ext cx="147485" cy="15417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C1A6A8B-C403-61EC-4D47-CEBA08B0372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584" t="43163" r="94194" b="53498"/>
          <a:stretch/>
        </p:blipFill>
        <p:spPr>
          <a:xfrm>
            <a:off x="1420889" y="7633262"/>
            <a:ext cx="152400" cy="1613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03C432A-AC64-EB05-C91F-4D08204FD4D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942" t="53404" r="94194" b="43927"/>
          <a:stretch/>
        </p:blipFill>
        <p:spPr>
          <a:xfrm>
            <a:off x="2281754" y="7952516"/>
            <a:ext cx="127821" cy="1290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DDFB874-4813-0A3E-FE6A-98B290E01AD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942" t="65569" r="94194" b="31934"/>
          <a:stretch/>
        </p:blipFill>
        <p:spPr>
          <a:xfrm>
            <a:off x="3418216" y="8379730"/>
            <a:ext cx="127821" cy="1206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E3334B6-525C-C281-B834-90C52CD7012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761" t="76536" r="93657" b="19834"/>
          <a:stretch/>
        </p:blipFill>
        <p:spPr>
          <a:xfrm>
            <a:off x="4583221" y="8604354"/>
            <a:ext cx="176981" cy="17543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0B4FFBD-3B25-378F-A646-C2AC4D4F1EB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870" t="24368" r="4194" b="54882"/>
          <a:stretch/>
        </p:blipFill>
        <p:spPr>
          <a:xfrm>
            <a:off x="206476" y="766920"/>
            <a:ext cx="6304936" cy="10028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1541EDF-DF25-D868-0F66-93AD00EF75E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656" t="15366" r="4300" b="66325"/>
          <a:stretch/>
        </p:blipFill>
        <p:spPr>
          <a:xfrm>
            <a:off x="184356" y="2263880"/>
            <a:ext cx="6312309" cy="88490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B49511C-568E-BE65-4009-D2A3A3529D9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656" t="46795" r="4300" b="36117"/>
          <a:stretch/>
        </p:blipFill>
        <p:spPr>
          <a:xfrm>
            <a:off x="184356" y="3333134"/>
            <a:ext cx="6312309" cy="82591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7A9ADE8-6835-B3E6-CFED-2C551784331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656" t="78376" r="4300" b="8045"/>
          <a:stretch/>
        </p:blipFill>
        <p:spPr>
          <a:xfrm>
            <a:off x="191730" y="4372897"/>
            <a:ext cx="6312309" cy="65630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49407E3-C420-30E3-E86B-BAEF7ADFF6C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086" t="6517" r="4301" b="90279"/>
          <a:stretch/>
        </p:blipFill>
        <p:spPr>
          <a:xfrm>
            <a:off x="213852" y="5031161"/>
            <a:ext cx="6282813" cy="15485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EAB94F9-797B-F9B8-CC74-731633C3BD0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764" t="75174" r="4301" b="7737"/>
          <a:stretch/>
        </p:blipFill>
        <p:spPr>
          <a:xfrm>
            <a:off x="213852" y="5434777"/>
            <a:ext cx="6304935" cy="82591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5407357-C4CA-1F20-5D34-28C00732833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3870" t="6365" r="4409" b="84328"/>
          <a:stretch/>
        </p:blipFill>
        <p:spPr>
          <a:xfrm>
            <a:off x="221225" y="6289490"/>
            <a:ext cx="6290188" cy="44982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982C674-3AF1-ABF9-146C-92AC64731E9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5573" t="81433" r="11847" b="14906"/>
          <a:stretch/>
        </p:blipFill>
        <p:spPr>
          <a:xfrm>
            <a:off x="5907692" y="8680976"/>
            <a:ext cx="176981" cy="1769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74978D3-B0CD-3389-A3DE-A2C5D86DD0D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5143" t="69842" r="11740" b="27260"/>
          <a:stretch/>
        </p:blipFill>
        <p:spPr>
          <a:xfrm>
            <a:off x="5874509" y="8233591"/>
            <a:ext cx="213851" cy="14011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47D0B77F-414D-1763-8146-87F038375C7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5358" t="49560" r="12062" b="47542"/>
          <a:stretch/>
        </p:blipFill>
        <p:spPr>
          <a:xfrm>
            <a:off x="5888070" y="7273153"/>
            <a:ext cx="186728" cy="14782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1265A39B-5ECF-23B2-EF0D-A0C65E5D734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5358" t="49560" r="12062" b="47542"/>
          <a:stretch/>
        </p:blipFill>
        <p:spPr>
          <a:xfrm>
            <a:off x="5892944" y="7622637"/>
            <a:ext cx="176981" cy="14011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E222BD40-6673-DAC5-1306-B410CA52E21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849" t="35812" r="21882" b="53203"/>
          <a:stretch/>
        </p:blipFill>
        <p:spPr>
          <a:xfrm>
            <a:off x="426537" y="7193863"/>
            <a:ext cx="1047136" cy="53094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460F98A-CC0D-DCE1-D902-E93F220F4E8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849" t="46339" r="25323" b="44812"/>
          <a:stretch/>
        </p:blipFill>
        <p:spPr>
          <a:xfrm>
            <a:off x="1595120" y="7510744"/>
            <a:ext cx="811161" cy="427703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7528CBF-4C9A-F95A-DE80-490D1CE9FBF8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849" t="55188" r="22097" b="33980"/>
          <a:stretch/>
        </p:blipFill>
        <p:spPr>
          <a:xfrm>
            <a:off x="2449740" y="7815724"/>
            <a:ext cx="1032387" cy="523568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5816D60-EE49-65EB-D2E8-BDF033ED320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849" t="65868" r="22097" b="22995"/>
          <a:stretch/>
        </p:blipFill>
        <p:spPr>
          <a:xfrm>
            <a:off x="3550834" y="8208997"/>
            <a:ext cx="1032387" cy="53831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67A3E4F3-612C-5499-E456-AA8AFB184449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2849" t="77005" r="22097" b="9722"/>
          <a:stretch/>
        </p:blipFill>
        <p:spPr>
          <a:xfrm>
            <a:off x="4724744" y="8472453"/>
            <a:ext cx="1032387" cy="64155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2C0D9A0-5B5F-F5F2-E2B7-829D645D42B4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5143" t="69842" r="11740" b="27260"/>
          <a:stretch/>
        </p:blipFill>
        <p:spPr>
          <a:xfrm>
            <a:off x="5874509" y="7946727"/>
            <a:ext cx="213851" cy="1401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3031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9AC1EBC-C3C4-62A5-EBD8-7754A114C72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797" t="29526" r="4258" b="65766"/>
          <a:stretch/>
        </p:blipFill>
        <p:spPr>
          <a:xfrm>
            <a:off x="253794" y="563043"/>
            <a:ext cx="6305550" cy="22755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65BC898-24C2-AEB7-E2B3-20B93264F93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1320" b="35287"/>
          <a:stretch/>
        </p:blipFill>
        <p:spPr>
          <a:xfrm>
            <a:off x="0" y="2156892"/>
            <a:ext cx="6858000" cy="16396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4B5C6AB-17AC-154C-E511-8DD57FCF887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15445" r="3981" b="57622"/>
          <a:stretch/>
        </p:blipFill>
        <p:spPr>
          <a:xfrm>
            <a:off x="228600" y="3375048"/>
            <a:ext cx="6305550" cy="130175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AF3BE81-E7EE-EBA9-BB65-08607144E82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797" t="39883" r="4258" b="39115"/>
          <a:stretch/>
        </p:blipFill>
        <p:spPr>
          <a:xfrm>
            <a:off x="203200" y="771548"/>
            <a:ext cx="6305550" cy="101504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9E83080-3954-1D02-5090-4102F0D877F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1051" b="44241"/>
          <a:stretch/>
        </p:blipFill>
        <p:spPr>
          <a:xfrm>
            <a:off x="6350" y="1939948"/>
            <a:ext cx="6858000" cy="22755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39B98B7-B5A6-DC01-7684-AAB9D307F07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70101" r="3492" b="13213"/>
          <a:stretch/>
        </p:blipFill>
        <p:spPr>
          <a:xfrm>
            <a:off x="228600" y="2282848"/>
            <a:ext cx="6389914" cy="80644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9F43DFE-6DAE-7D3B-5405-2965213CF7A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5987" r="3981" b="90334"/>
          <a:stretch/>
        </p:blipFill>
        <p:spPr>
          <a:xfrm>
            <a:off x="215900" y="3178198"/>
            <a:ext cx="6305550" cy="177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3AD661E-F661-BE80-2AAF-4F5FEA3D4C6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46584" r="3981" b="36205"/>
          <a:stretch/>
        </p:blipFill>
        <p:spPr>
          <a:xfrm>
            <a:off x="222250" y="4403748"/>
            <a:ext cx="6305550" cy="83185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6E4DABD-3273-729C-7F01-486A774784D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37495" r="3981" b="59332"/>
          <a:stretch/>
        </p:blipFill>
        <p:spPr>
          <a:xfrm>
            <a:off x="228600" y="4218554"/>
            <a:ext cx="6305550" cy="15335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987673F-3C2D-7370-F6A5-C52D4B1EF5A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33781" r="3492" b="61173"/>
          <a:stretch/>
        </p:blipFill>
        <p:spPr>
          <a:xfrm>
            <a:off x="219891" y="5345004"/>
            <a:ext cx="6389914" cy="2438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654EC98-CE2B-B317-8706-8D442D93E5C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43536" r="3492" b="30986"/>
          <a:stretch/>
        </p:blipFill>
        <p:spPr>
          <a:xfrm>
            <a:off x="206828" y="5533324"/>
            <a:ext cx="6389914" cy="123117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FCF1FAA-2894-EBCE-EACC-2EDF25A770B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73068" r="3492" b="21886"/>
          <a:stretch/>
        </p:blipFill>
        <p:spPr>
          <a:xfrm>
            <a:off x="211181" y="6764495"/>
            <a:ext cx="6389914" cy="24384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3F7150E-755B-6682-AFA0-F852D59F9D4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83284" r="3492" b="10803"/>
          <a:stretch/>
        </p:blipFill>
        <p:spPr>
          <a:xfrm>
            <a:off x="206825" y="6966425"/>
            <a:ext cx="6389914" cy="28574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C0B77E9-2000-CBA3-25C2-019F82F63E9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2389" t="6309" r="22117" b="80702"/>
          <a:stretch/>
        </p:blipFill>
        <p:spPr>
          <a:xfrm>
            <a:off x="444128" y="7216854"/>
            <a:ext cx="1062446" cy="62769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31CD1A6-CBBB-7196-1775-AD63B599B0F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5417" t="9797" r="11789" b="85239"/>
          <a:stretch/>
        </p:blipFill>
        <p:spPr>
          <a:xfrm>
            <a:off x="5877868" y="7302345"/>
            <a:ext cx="191589" cy="23984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EA9AFE6-8E12-F45F-7D24-05DA9728B39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44" t="20063" r="93862" b="73838"/>
          <a:stretch/>
        </p:blipFill>
        <p:spPr>
          <a:xfrm>
            <a:off x="1314985" y="7549825"/>
            <a:ext cx="191589" cy="29472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5C99365-AAE0-9AF2-840E-76582DC7B78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2389" t="19022" r="22117" b="71909"/>
          <a:stretch/>
        </p:blipFill>
        <p:spPr>
          <a:xfrm>
            <a:off x="1506574" y="7557428"/>
            <a:ext cx="1062446" cy="43824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622DCCA-4A06-AE36-306F-9BF5E0C24D1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5417" t="20624" r="11789" b="73857"/>
          <a:stretch/>
        </p:blipFill>
        <p:spPr>
          <a:xfrm>
            <a:off x="5877868" y="7592369"/>
            <a:ext cx="191589" cy="26670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3929C34-A9FF-7B37-26E9-D7A6A8FC818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44" t="30487" r="93862" b="66471"/>
          <a:stretch/>
        </p:blipFill>
        <p:spPr>
          <a:xfrm>
            <a:off x="2306857" y="7940149"/>
            <a:ext cx="191589" cy="14698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37D91C1-15D1-D511-B1AE-9698E64A5DA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2389" t="27222" r="22117" b="63708"/>
          <a:stretch/>
        </p:blipFill>
        <p:spPr>
          <a:xfrm>
            <a:off x="2498446" y="7867739"/>
            <a:ext cx="1062446" cy="438241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87AC8F5-94C6-7AD1-078C-9EF0F3F6F30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5417" t="20624" r="11789" b="73857"/>
          <a:stretch/>
        </p:blipFill>
        <p:spPr>
          <a:xfrm>
            <a:off x="5877868" y="7886770"/>
            <a:ext cx="191589" cy="26670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6D949D06-E994-47FF-D875-75C6885D9F7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44" t="39883" r="93862" b="55598"/>
          <a:stretch/>
        </p:blipFill>
        <p:spPr>
          <a:xfrm>
            <a:off x="3243761" y="8305980"/>
            <a:ext cx="191589" cy="21836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B5FFBF23-641A-B6C3-0C8A-25609E8EC84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2389" t="36292" r="22117" b="52924"/>
          <a:stretch/>
        </p:blipFill>
        <p:spPr>
          <a:xfrm>
            <a:off x="3401782" y="8183985"/>
            <a:ext cx="1062446" cy="521055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C793445-A468-770B-5484-85582DA9133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5070" t="39690" r="12136" b="55625"/>
          <a:stretch/>
        </p:blipFill>
        <p:spPr>
          <a:xfrm>
            <a:off x="5857396" y="8234555"/>
            <a:ext cx="191589" cy="22642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F6E72853-AEB2-C9A5-9ADA-9C65FC8DD8E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44" t="48822" r="93862" b="46213"/>
          <a:stretch/>
        </p:blipFill>
        <p:spPr>
          <a:xfrm>
            <a:off x="4192886" y="8629085"/>
            <a:ext cx="191589" cy="239904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0967B374-FEA4-3152-537F-64A7085B6F1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2608" t="46806" r="21898" b="42410"/>
          <a:stretch/>
        </p:blipFill>
        <p:spPr>
          <a:xfrm>
            <a:off x="4462147" y="8524344"/>
            <a:ext cx="1062446" cy="52105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7BEF2FB-336C-E383-3D09-EF494FB0324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31" t="11024" r="93862" b="85214"/>
          <a:stretch/>
        </p:blipFill>
        <p:spPr>
          <a:xfrm>
            <a:off x="272179" y="7379742"/>
            <a:ext cx="171949" cy="18180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9D8C035-42B6-F0E7-5F7E-2349C0A7F18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4997" t="49738" r="11421" b="46591"/>
          <a:stretch/>
        </p:blipFill>
        <p:spPr>
          <a:xfrm>
            <a:off x="5850832" y="8616329"/>
            <a:ext cx="245660" cy="177421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E36BCBCB-F6F7-7E45-036C-A9881FA5CD5F}"/>
              </a:ext>
            </a:extLst>
          </p:cNvPr>
          <p:cNvSpPr txBox="1"/>
          <p:nvPr/>
        </p:nvSpPr>
        <p:spPr>
          <a:xfrm>
            <a:off x="6350" y="-26250"/>
            <a:ext cx="15712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S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375344C-ECAB-A6CC-7F49-5B6CC35C70DA}"/>
              </a:ext>
            </a:extLst>
          </p:cNvPr>
          <p:cNvSpPr txBox="1"/>
          <p:nvPr/>
        </p:nvSpPr>
        <p:spPr>
          <a:xfrm>
            <a:off x="11056" y="293842"/>
            <a:ext cx="7099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genuity Pathway Analysis Modified Proteomic Summary, Astrocytes Treated with F3-8 EVs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A8FEBB15-C491-5E43-2403-99E796BD96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364" t="82995" r="22872" b="11033"/>
          <a:stretch/>
        </p:blipFill>
        <p:spPr>
          <a:xfrm>
            <a:off x="2867606" y="6956028"/>
            <a:ext cx="943897" cy="288623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74C5457F-1FAD-7054-A1EC-43FA15DC6A5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805" t="83224" r="39969" b="10803"/>
          <a:stretch/>
        </p:blipFill>
        <p:spPr>
          <a:xfrm>
            <a:off x="4041058" y="6963402"/>
            <a:ext cx="1592826" cy="288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6532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603CA3A-ADE6-2A16-594B-19203A804D1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797" t="29526" r="4258" b="65766"/>
          <a:stretch/>
        </p:blipFill>
        <p:spPr>
          <a:xfrm>
            <a:off x="261168" y="563043"/>
            <a:ext cx="6305550" cy="2275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34E9745-B537-88D6-42CA-E4A2C02C4D9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1051" b="44241"/>
          <a:stretch/>
        </p:blipFill>
        <p:spPr>
          <a:xfrm>
            <a:off x="6350" y="1939948"/>
            <a:ext cx="6858000" cy="22755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C4B9B06-4591-C5D4-2EA0-19C8C7FEDA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5987" r="3981" b="90334"/>
          <a:stretch/>
        </p:blipFill>
        <p:spPr>
          <a:xfrm>
            <a:off x="215900" y="3142876"/>
            <a:ext cx="6305550" cy="177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9782469-3783-09EE-AB19-C729BBB98A9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075" t="37495" r="3981" b="59332"/>
          <a:stretch/>
        </p:blipFill>
        <p:spPr>
          <a:xfrm>
            <a:off x="228600" y="4173916"/>
            <a:ext cx="6305550" cy="15335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128327-8C4A-CF34-4E32-41A72269DB0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33781" r="3492" b="61173"/>
          <a:stretch/>
        </p:blipFill>
        <p:spPr>
          <a:xfrm>
            <a:off x="219891" y="5224684"/>
            <a:ext cx="6389914" cy="24384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23BBA0-5168-7695-14F7-6DE6CE9D42B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73068" r="3492" b="21886"/>
          <a:stretch/>
        </p:blipFill>
        <p:spPr>
          <a:xfrm>
            <a:off x="211181" y="6608079"/>
            <a:ext cx="6389914" cy="2438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01F2FE2-DBF6-D08F-43D9-551C7F33B78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33" t="83284" r="3492" b="10803"/>
          <a:stretch/>
        </p:blipFill>
        <p:spPr>
          <a:xfrm>
            <a:off x="206825" y="6785945"/>
            <a:ext cx="6389914" cy="28574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859762E-E31E-EF12-530F-CBDA094BE0A3}"/>
              </a:ext>
            </a:extLst>
          </p:cNvPr>
          <p:cNvSpPr txBox="1"/>
          <p:nvPr/>
        </p:nvSpPr>
        <p:spPr>
          <a:xfrm>
            <a:off x="6350" y="-26250"/>
            <a:ext cx="15712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 S6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3239D4D-8D7B-B919-DCD3-AF8A14B6C7C8}"/>
              </a:ext>
            </a:extLst>
          </p:cNvPr>
          <p:cNvSpPr txBox="1"/>
          <p:nvPr/>
        </p:nvSpPr>
        <p:spPr>
          <a:xfrm>
            <a:off x="-55310" y="293842"/>
            <a:ext cx="7099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genuity Pathway Analysis Modified Proteomic Summary, Astrocytes Treated with G17-1 EV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0A75001-FD6B-C91F-C419-B92F54A0E44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364" t="83210" r="22872" b="11033"/>
          <a:stretch/>
        </p:blipFill>
        <p:spPr>
          <a:xfrm>
            <a:off x="2867606" y="6781789"/>
            <a:ext cx="943897" cy="27822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A3FC25E-35C7-AB37-0957-21234CD7471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619" t="69987" r="4722" b="10484"/>
          <a:stretch/>
        </p:blipFill>
        <p:spPr>
          <a:xfrm>
            <a:off x="258804" y="751360"/>
            <a:ext cx="6285955" cy="94389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8AFE83C-FE12-7BB5-9D1F-CA284422F08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979" t="15519" r="4086" b="67545"/>
          <a:stretch/>
        </p:blipFill>
        <p:spPr>
          <a:xfrm>
            <a:off x="280218" y="2330246"/>
            <a:ext cx="6304937" cy="81853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347B12D-3C40-7B06-2832-A9E9C2CB883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979" t="46491" r="4086" b="35658"/>
          <a:stretch/>
        </p:blipFill>
        <p:spPr>
          <a:xfrm>
            <a:off x="272844" y="3278411"/>
            <a:ext cx="6304937" cy="8627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D898D37-32D8-DFEC-7835-289530EEEEE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979" t="77770" r="4086" b="7736"/>
          <a:stretch/>
        </p:blipFill>
        <p:spPr>
          <a:xfrm>
            <a:off x="272844" y="4328265"/>
            <a:ext cx="6304937" cy="70054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497741F-E6A2-42C0-7E85-3F6A3659299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549" t="5601" r="6237" b="90585"/>
          <a:stretch/>
        </p:blipFill>
        <p:spPr>
          <a:xfrm>
            <a:off x="243348" y="5014064"/>
            <a:ext cx="6186949" cy="18435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10E7675-038E-3125-96F9-12A76E475CC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3655" t="74869" r="4517" b="7279"/>
          <a:stretch/>
        </p:blipFill>
        <p:spPr>
          <a:xfrm>
            <a:off x="250722" y="5429735"/>
            <a:ext cx="6297561" cy="86278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C1AEE78-2E3B-0E5D-26F2-74E15EAF252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656" t="6059" r="4517" b="88906"/>
          <a:stretch/>
        </p:blipFill>
        <p:spPr>
          <a:xfrm>
            <a:off x="250722" y="6277768"/>
            <a:ext cx="6297561" cy="24335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C566F1E-51C5-C9B8-5BE1-A44F7B143C0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656" t="33790" r="94194" b="63020"/>
          <a:stretch/>
        </p:blipFill>
        <p:spPr>
          <a:xfrm>
            <a:off x="243348" y="7025822"/>
            <a:ext cx="147485" cy="15417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E6D7A38-6949-3879-5360-C2F450CBDDE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289" t="32852" r="11748" b="61899"/>
          <a:stretch/>
        </p:blipFill>
        <p:spPr>
          <a:xfrm>
            <a:off x="5861053" y="7176835"/>
            <a:ext cx="203201" cy="25370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9704E52-E59B-00FC-FAAC-C853DDA02E3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289" t="32852" r="11748" b="61899"/>
          <a:stretch/>
        </p:blipFill>
        <p:spPr>
          <a:xfrm>
            <a:off x="5861053" y="7552390"/>
            <a:ext cx="203201" cy="25370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C553669D-1E08-1DD9-0149-0EAE016C73D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805" t="83224" r="39969" b="10803"/>
          <a:stretch/>
        </p:blipFill>
        <p:spPr>
          <a:xfrm>
            <a:off x="4041058" y="6782922"/>
            <a:ext cx="1592826" cy="28862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C2A2BF0-BBF9-5409-58DD-E5CAD52B6C8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541" t="53831" r="11061" b="42979"/>
          <a:stretch/>
        </p:blipFill>
        <p:spPr>
          <a:xfrm>
            <a:off x="5846112" y="8053290"/>
            <a:ext cx="233083" cy="15417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459EC84-03DB-3D62-3205-612D1EA8F96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541" t="77077" r="11496" b="19708"/>
          <a:stretch/>
        </p:blipFill>
        <p:spPr>
          <a:xfrm>
            <a:off x="5861053" y="8318799"/>
            <a:ext cx="203200" cy="155389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9884CC2-7B63-B8EE-9482-358CF9C3FD8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5541" t="77077" r="11496" b="19708"/>
          <a:stretch/>
        </p:blipFill>
        <p:spPr>
          <a:xfrm>
            <a:off x="5861053" y="8724228"/>
            <a:ext cx="203200" cy="155389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A99A732B-B1E2-ED49-27DF-2BF47A4A28A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534" t="30956" r="22042" b="60265"/>
          <a:stretch/>
        </p:blipFill>
        <p:spPr>
          <a:xfrm>
            <a:off x="390833" y="7065881"/>
            <a:ext cx="1057835" cy="42432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66CA4F9-A6FD-D0EB-A7A2-CA2533F6929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4096" t="43700" r="93979" b="53395"/>
          <a:stretch/>
        </p:blipFill>
        <p:spPr>
          <a:xfrm>
            <a:off x="1285695" y="7581297"/>
            <a:ext cx="132029" cy="14042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9C88977-08CD-CE54-1A48-9D7003BEFDE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935" t="53203" r="93888" b="43581"/>
          <a:stretch/>
        </p:blipFill>
        <p:spPr>
          <a:xfrm>
            <a:off x="2189277" y="8020190"/>
            <a:ext cx="149411" cy="15545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529FF5A-2B60-7AE4-772D-0C9A8305E09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534" t="39982" r="22042" b="49384"/>
          <a:stretch/>
        </p:blipFill>
        <p:spPr>
          <a:xfrm>
            <a:off x="1417724" y="7456236"/>
            <a:ext cx="1057835" cy="51397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9372E52-4341-0652-4C0A-32D78177A18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892" t="65440" r="93122" b="31515"/>
          <a:stretch/>
        </p:blipFill>
        <p:spPr>
          <a:xfrm>
            <a:off x="3362487" y="8346422"/>
            <a:ext cx="204888" cy="147183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AFDAD9E-8BED-4EEB-921E-2C118E8156E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867" t="76930" r="93148" b="19277"/>
          <a:stretch/>
        </p:blipFill>
        <p:spPr>
          <a:xfrm>
            <a:off x="4548160" y="8710239"/>
            <a:ext cx="204888" cy="183366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EB32B1D8-7C45-7381-EAA3-977CE12722B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534" t="50739" r="22042" b="40358"/>
          <a:stretch/>
        </p:blipFill>
        <p:spPr>
          <a:xfrm>
            <a:off x="2338688" y="7920704"/>
            <a:ext cx="1057835" cy="43030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A40F138E-5107-2961-BC12-4899DEAC303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534" t="59147" r="22042" b="26014"/>
          <a:stretch/>
        </p:blipFill>
        <p:spPr>
          <a:xfrm>
            <a:off x="3492695" y="8150177"/>
            <a:ext cx="1057835" cy="717176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E43E4D4A-DF45-FF1A-E3CC-FC43B9C890D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2534" t="74110" r="22042" b="16492"/>
          <a:stretch/>
        </p:blipFill>
        <p:spPr>
          <a:xfrm>
            <a:off x="4720889" y="8595347"/>
            <a:ext cx="1057835" cy="454211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3714F6ED-8AF2-92DE-F92F-90A8F6434D6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61320" b="35287"/>
          <a:stretch/>
        </p:blipFill>
        <p:spPr>
          <a:xfrm>
            <a:off x="0" y="2179014"/>
            <a:ext cx="6858000" cy="163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9455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1</TotalTime>
  <Words>161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raner</dc:creator>
  <cp:lastModifiedBy>Michael Graner</cp:lastModifiedBy>
  <cp:revision>10</cp:revision>
  <dcterms:created xsi:type="dcterms:W3CDTF">2022-12-27T03:57:34Z</dcterms:created>
  <dcterms:modified xsi:type="dcterms:W3CDTF">2023-03-14T21:44:58Z</dcterms:modified>
</cp:coreProperties>
</file>